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A90371-45C8-46F3-B8B0-16004CAB2C3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A0BE48-5BED-4743-A44F-C2B1B93D037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242EE1-217E-412F-9041-90D16654AC5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B4C87F-DC33-4887-BE3F-B660256CDD3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C77311-A3EC-497B-9D71-064192BB0B4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E49674-23F1-4159-B8F6-FF43095FB04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7B81E0-3CB1-4E3E-BF70-A223C16E67B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FD559F-260A-4284-81AE-C1D2EEF71F5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391CD5-2DE3-40FB-92C5-21833AD7C57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08997A-4E9C-4446-812A-F88FDA07C40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6A6134-B162-4F8F-B515-F5BD53D368A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5FF11D-77B9-4F25-8891-8D4E595CBAD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79E063E-A132-40BA-8705-E6B5B51CED58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4"/>
          <p:cNvSpPr/>
          <p:nvPr/>
        </p:nvSpPr>
        <p:spPr>
          <a:xfrm>
            <a:off x="675000" y="1941480"/>
            <a:ext cx="802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CF7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 Box 5"/>
          <p:cNvSpPr/>
          <p:nvPr/>
        </p:nvSpPr>
        <p:spPr>
          <a:xfrm>
            <a:off x="692640" y="4648320"/>
            <a:ext cx="953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U 14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3" name="Picture 7" descr=""/>
          <p:cNvPicPr/>
          <p:nvPr/>
        </p:nvPicPr>
        <p:blipFill>
          <a:blip r:embed="rId1"/>
          <a:srcRect l="2815" t="9624" r="21127" b="25774"/>
          <a:stretch/>
        </p:blipFill>
        <p:spPr>
          <a:xfrm>
            <a:off x="2133720" y="685800"/>
            <a:ext cx="3504960" cy="3051000"/>
          </a:xfrm>
          <a:prstGeom prst="rect">
            <a:avLst/>
          </a:prstGeom>
          <a:ln w="0">
            <a:noFill/>
          </a:ln>
        </p:spPr>
      </p:pic>
      <p:pic>
        <p:nvPicPr>
          <p:cNvPr id="44" name="Picture 8" descr=""/>
          <p:cNvPicPr/>
          <p:nvPr/>
        </p:nvPicPr>
        <p:blipFill>
          <a:blip r:embed="rId2"/>
          <a:srcRect l="4613" t="11001" r="44668" b="27151"/>
          <a:stretch/>
        </p:blipFill>
        <p:spPr>
          <a:xfrm>
            <a:off x="2286000" y="3657600"/>
            <a:ext cx="2830680" cy="2895480"/>
          </a:xfrm>
          <a:prstGeom prst="rect">
            <a:avLst/>
          </a:prstGeom>
          <a:ln w="0">
            <a:noFill/>
          </a:ln>
        </p:spPr>
      </p:pic>
      <p:graphicFrame>
        <p:nvGraphicFramePr>
          <p:cNvPr id="45" name=""/>
          <p:cNvGraphicFramePr/>
          <p:nvPr/>
        </p:nvGraphicFramePr>
        <p:xfrm>
          <a:off x="5257800" y="4114800"/>
          <a:ext cx="3352680" cy="1219320"/>
        </p:xfrm>
        <a:graphic>
          <a:graphicData uri="http://schemas.openxmlformats.org/drawingml/2006/table">
            <a:tbl>
              <a:tblPr/>
              <a:tblGrid>
                <a:gridCol w="733320"/>
                <a:gridCol w="785880"/>
                <a:gridCol w="863640"/>
                <a:gridCol w="969840"/>
              </a:tblGrid>
              <a:tr h="2952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3"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FI  (PE-1H7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3240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R1*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ex-hR1*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998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CF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9.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8.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7.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0024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U 14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7.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7.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8.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6" name="TextBox 10"/>
          <p:cNvSpPr/>
          <p:nvPr/>
        </p:nvSpPr>
        <p:spPr>
          <a:xfrm>
            <a:off x="189360" y="136440"/>
            <a:ext cx="1233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ure S9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Box 11"/>
          <p:cNvSpPr/>
          <p:nvPr/>
        </p:nvSpPr>
        <p:spPr>
          <a:xfrm>
            <a:off x="5608440" y="5673600"/>
            <a:ext cx="708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* 10 n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8" name=""/>
          <p:cNvGraphicFramePr/>
          <p:nvPr/>
        </p:nvGraphicFramePr>
        <p:xfrm>
          <a:off x="5334120" y="1295280"/>
          <a:ext cx="3124080" cy="1212840"/>
        </p:xfrm>
        <a:graphic>
          <a:graphicData uri="http://schemas.openxmlformats.org/drawingml/2006/table">
            <a:tbl>
              <a:tblPr/>
              <a:tblGrid>
                <a:gridCol w="742680"/>
                <a:gridCol w="2381400"/>
              </a:tblGrid>
              <a:tr h="3070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ample ID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070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9933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ells treated with Hex-hR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070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ccff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ells treated with hR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070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Untreated Control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8-06T16:12:32Z</dcterms:created>
  <dc:creator>yawang</dc:creator>
  <dc:description/>
  <dc:language>en-US</dc:language>
  <cp:lastModifiedBy>yawang</cp:lastModifiedBy>
  <dcterms:modified xsi:type="dcterms:W3CDTF">2012-08-06T16:43:56Z</dcterms:modified>
  <cp:revision>11</cp:revision>
  <dc:subject/>
  <dc:title>Slide 1</dc:title>
</cp:coreProperties>
</file>